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5FCFF-C7D1-48D0-955F-ABB61455C8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12F6D-64BE-488B-BFF9-53274C8758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1B9D5-5F0E-4243-ACC3-4FA30E7DA1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46CB9-D017-4801-8083-7874227959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2F238-E6CC-48D2-AC41-8D1786BE3C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A064A-F14B-4F6D-B0D6-5F8EB5A424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557FA-F4B5-48E6-BA7A-6981162DA9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99510-795E-41E9-B3E6-A30D10C236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6D423-1015-467E-9FCC-D8E00A0C5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FFFA9-9066-4D29-8F5C-7237BF5E67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EACEB-F6C2-45A2-9400-BD2803A981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DFF65-5F63-49B5-8415-CBB73BC5A8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C39C65-690E-4BE2-84EC-6CE409CAE170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2" descr="%CD4naive vs AGe control Nouna.jpg"/>
          <p:cNvPicPr/>
          <p:nvPr/>
        </p:nvPicPr>
        <p:blipFill>
          <a:blip r:embed="rId1"/>
          <a:stretch/>
        </p:blipFill>
        <p:spPr>
          <a:xfrm>
            <a:off x="826920" y="3429000"/>
            <a:ext cx="3600720" cy="2558880"/>
          </a:xfrm>
          <a:prstGeom prst="rect">
            <a:avLst/>
          </a:prstGeom>
          <a:ln w="0">
            <a:noFill/>
          </a:ln>
        </p:spPr>
      </p:pic>
      <p:pic>
        <p:nvPicPr>
          <p:cNvPr id="42" name="Grafik 3" descr="%CD8naive vs Age control Nouna.jpg"/>
          <p:cNvPicPr/>
          <p:nvPr/>
        </p:nvPicPr>
        <p:blipFill>
          <a:blip r:embed="rId2"/>
          <a:stretch/>
        </p:blipFill>
        <p:spPr>
          <a:xfrm>
            <a:off x="4572000" y="3429000"/>
            <a:ext cx="3529080" cy="2506680"/>
          </a:xfrm>
          <a:prstGeom prst="rect">
            <a:avLst/>
          </a:prstGeom>
          <a:ln w="0">
            <a:noFill/>
          </a:ln>
        </p:spPr>
      </p:pic>
      <p:sp>
        <p:nvSpPr>
          <p:cNvPr id="43" name="Textfeld 9"/>
          <p:cNvSpPr/>
          <p:nvPr/>
        </p:nvSpPr>
        <p:spPr>
          <a:xfrm>
            <a:off x="686160" y="3429000"/>
            <a:ext cx="315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feld 10"/>
          <p:cNvSpPr/>
          <p:nvPr/>
        </p:nvSpPr>
        <p:spPr>
          <a:xfrm>
            <a:off x="4400640" y="3429000"/>
            <a:ext cx="340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feld 14"/>
          <p:cNvSpPr/>
          <p:nvPr/>
        </p:nvSpPr>
        <p:spPr>
          <a:xfrm>
            <a:off x="8029080" y="4581360"/>
            <a:ext cx="81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Nou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15"/>
          <p:cNvSpPr/>
          <p:nvPr/>
        </p:nvSpPr>
        <p:spPr>
          <a:xfrm>
            <a:off x="324000" y="6165720"/>
            <a:ext cx="8496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Supplementary material c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The percentage of naïve CD8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T cells decreased slightly but significantly with increasing age in Ouagadougou (urban, panel A and B) controls. This correlation did not reach statistical significance in healthy adults living in Nouna (rural setting, panel C and D)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. The decrease of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naïve C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T cells was not statistically significant in both setting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Grafik 11" descr="%NAive CD4 vs AGE Ouaga control.jpg"/>
          <p:cNvPicPr/>
          <p:nvPr/>
        </p:nvPicPr>
        <p:blipFill>
          <a:blip r:embed="rId3"/>
          <a:stretch/>
        </p:blipFill>
        <p:spPr>
          <a:xfrm>
            <a:off x="900000" y="963720"/>
            <a:ext cx="3435480" cy="2465280"/>
          </a:xfrm>
          <a:prstGeom prst="rect">
            <a:avLst/>
          </a:prstGeom>
          <a:ln w="0">
            <a:noFill/>
          </a:ln>
        </p:spPr>
      </p:pic>
      <p:pic>
        <p:nvPicPr>
          <p:cNvPr id="48" name="Grafik 18" descr="%Naive CD8 vs Age Ouaga control.jpg"/>
          <p:cNvPicPr/>
          <p:nvPr/>
        </p:nvPicPr>
        <p:blipFill>
          <a:blip r:embed="rId4"/>
          <a:stretch/>
        </p:blipFill>
        <p:spPr>
          <a:xfrm>
            <a:off x="4572000" y="905040"/>
            <a:ext cx="3456000" cy="2523960"/>
          </a:xfrm>
          <a:prstGeom prst="rect">
            <a:avLst/>
          </a:prstGeom>
          <a:ln w="0">
            <a:noFill/>
          </a:ln>
        </p:spPr>
      </p:pic>
      <p:sp>
        <p:nvSpPr>
          <p:cNvPr id="49" name="Textfeld 19"/>
          <p:cNvSpPr/>
          <p:nvPr/>
        </p:nvSpPr>
        <p:spPr>
          <a:xfrm>
            <a:off x="755640" y="907920"/>
            <a:ext cx="287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feld 20"/>
          <p:cNvSpPr/>
          <p:nvPr/>
        </p:nvSpPr>
        <p:spPr>
          <a:xfrm>
            <a:off x="4427640" y="907920"/>
            <a:ext cx="287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feld 17"/>
          <p:cNvSpPr/>
          <p:nvPr/>
        </p:nvSpPr>
        <p:spPr>
          <a:xfrm>
            <a:off x="7632000" y="1844640"/>
            <a:ext cx="151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Ouagadougo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1T15:19:32Z</dcterms:created>
  <dc:creator>Fabrice Tiba</dc:creator>
  <dc:description/>
  <dc:language>en-US</dc:language>
  <cp:lastModifiedBy>LG</cp:lastModifiedBy>
  <dcterms:modified xsi:type="dcterms:W3CDTF">2011-11-04T16:39:57Z</dcterms:modified>
  <cp:revision>88</cp:revision>
  <dc:subject/>
  <dc:title>Folie 1</dc:title>
</cp:coreProperties>
</file>